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48" y="9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449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511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290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301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564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448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806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173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725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855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2842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0121DC-383C-48CC-AC61-E0480D0FAA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BF6E0-BB5E-440F-A836-8FA965D65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382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5657" y="496390"/>
            <a:ext cx="9155748" cy="525247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814872" y="5966767"/>
            <a:ext cx="11345333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4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benzylate chloroquinolines against resistant strain K1. Compound 8d was removed from this analysis because of its non-detectable anti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ozo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.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59035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8:29Z</dcterms:created>
  <dcterms:modified xsi:type="dcterms:W3CDTF">2020-08-04T16:33:39Z</dcterms:modified>
</cp:coreProperties>
</file>